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79" r:id="rId3"/>
  </p:sldIdLst>
  <p:sldSz cx="9144000" cy="6858000" type="screen4x3"/>
  <p:notesSz cx="6858000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1474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6603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2620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2749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1092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3245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761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0102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6437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5696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4767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5949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3385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25644"/>
            <a:ext cx="13676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Fig. </a:t>
            </a:r>
            <a:r>
              <a:rPr lang="de-DE" sz="1400" b="1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1967538"/>
            <a:ext cx="4320000" cy="2397566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1967538"/>
            <a:ext cx="4320000" cy="2397566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4386644"/>
            <a:ext cx="4320000" cy="2342286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837297" y="1945998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666-1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5157297" y="1963964"/>
            <a:ext cx="1074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17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ne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837297" y="4352667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K1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5220072" y="4352666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TW01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59447BA4-3043-4F24-855E-AE88712CE54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4386644"/>
            <a:ext cx="4320000" cy="2354724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0" y="284455"/>
            <a:ext cx="907355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ffect of radiotherapy on cell viability and apoptosi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NPC cells were irradiated with doses from 0 to 6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Cell viability was determined by MTT test between 24 h and 72 h after irradiation. Data are presented as means ± S.E.M. The one-way repeated measures ANOVA documented significant changes in the percentage of living cells starting 24 h after radiation (ANOVA: *  p &lt; 0.05; ** p &lt; 0.01; *** p &lt; 0.001). B NPC cells were treated as above and apoptosis was determined by flow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ytometr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alysi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ubdiploi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NA-content between 24 h and 72 h after irradiation. Data are presented as means ± S.E.M., each experiment was done three times (Student's t- test: * p &lt; 0.05; ** p &lt; 0.01; *** p &lt; 0.001)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79512" y="16349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5382605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>
            <a:extLst>
              <a:ext uri="{FF2B5EF4-FFF2-40B4-BE49-F238E27FC236}">
                <a16:creationId xmlns:a16="http://schemas.microsoft.com/office/drawing/2014/main" id="{56747D95-C5F5-44BE-904A-4F81E8BFC3A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480" y="1067728"/>
            <a:ext cx="4320000" cy="2361272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34B1EF53-90F8-4C1D-89FF-390ED4FDC5F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480" y="3489974"/>
            <a:ext cx="4320000" cy="2356457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B0ADF9D8-CD8A-447C-BB24-C03412980969}"/>
              </a:ext>
            </a:extLst>
          </p:cNvPr>
          <p:cNvSpPr txBox="1"/>
          <p:nvPr/>
        </p:nvSpPr>
        <p:spPr>
          <a:xfrm>
            <a:off x="861258" y="980729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666-1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6AC57DD4-073B-4501-90E2-F831293988AD}"/>
              </a:ext>
            </a:extLst>
          </p:cNvPr>
          <p:cNvSpPr txBox="1"/>
          <p:nvPr/>
        </p:nvSpPr>
        <p:spPr>
          <a:xfrm>
            <a:off x="5489133" y="980728"/>
            <a:ext cx="10743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17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ine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FEC5D190-1D3B-47CC-A27B-96BF77D4D4CE}"/>
              </a:ext>
            </a:extLst>
          </p:cNvPr>
          <p:cNvSpPr txBox="1"/>
          <p:nvPr/>
        </p:nvSpPr>
        <p:spPr>
          <a:xfrm>
            <a:off x="837297" y="348997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K1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1701E371-6CFD-43EE-BAB4-84BD18986C76}"/>
              </a:ext>
            </a:extLst>
          </p:cNvPr>
          <p:cNvSpPr txBox="1"/>
          <p:nvPr/>
        </p:nvSpPr>
        <p:spPr>
          <a:xfrm>
            <a:off x="5561141" y="3429000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TW01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69F7A86F-57C4-4090-B47D-5D3607AAE9B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64994"/>
            <a:ext cx="4320000" cy="2364006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A2AD0539-E50B-4EE6-B551-663AEF2C8F5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89974"/>
            <a:ext cx="4320000" cy="2307250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251520" y="50280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639543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</Words>
  <Application>Microsoft Office PowerPoint</Application>
  <PresentationFormat>On-screen Show (4:3)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Larissa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ia</dc:creator>
  <cp:lastModifiedBy>MDPI</cp:lastModifiedBy>
  <cp:revision>96</cp:revision>
  <cp:lastPrinted>2021-08-06T07:00:33Z</cp:lastPrinted>
  <dcterms:created xsi:type="dcterms:W3CDTF">2020-05-04T20:02:04Z</dcterms:created>
  <dcterms:modified xsi:type="dcterms:W3CDTF">2021-09-17T12:34:43Z</dcterms:modified>
</cp:coreProperties>
</file>